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2.png" ContentType="image/png"/>
  <Override PartName="/ppt/media/image9.png" ContentType="image/png"/>
  <Override PartName="/ppt/media/image8.jpeg" ContentType="image/jpeg"/>
  <Override PartName="/ppt/media/image11.png" ContentType="image/png"/>
  <Override PartName="/ppt/media/image17.jpeg" ContentType="image/jpeg"/>
  <Override PartName="/ppt/media/image14.png" ContentType="image/png"/>
  <Override PartName="/ppt/media/image16.png" ContentType="image/png"/>
  <Override PartName="/ppt/media/image1.jpeg" ContentType="image/jpeg"/>
  <Override PartName="/ppt/media/image2.jpeg" ContentType="image/jpeg"/>
  <Override PartName="/ppt/media/image5.jpeg" ContentType="image/jpeg"/>
  <Override PartName="/ppt/media/image15.png" ContentType="image/png"/>
  <Override PartName="/ppt/media/image3.jpeg" ContentType="image/jpeg"/>
  <Override PartName="/ppt/media/image4.jpeg" ContentType="image/jpeg"/>
  <Override PartName="/ppt/media/image10.png" ContentType="image/png"/>
  <Override PartName="/ppt/media/image6.jpeg" ContentType="image/jpeg"/>
  <Override PartName="/ppt/media/image13.png" ContentType="image/png"/>
  <Override PartName="/ppt/media/image7.jpeg" ContentType="image/jpeg"/>
  <Override PartName="/ppt/media/image18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6008688" cy="831215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314EBA-50DC-4B65-93C9-03463B0C84E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99880" y="333000"/>
            <a:ext cx="5407200" cy="138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99880" y="1939680"/>
            <a:ext cx="5407200" cy="2616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99880" y="4804560"/>
            <a:ext cx="5407200" cy="2616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A8B0B9-D464-42DE-9D58-337CF57F91A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99880" y="333000"/>
            <a:ext cx="5407200" cy="138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99880" y="1939680"/>
            <a:ext cx="2638440" cy="2616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070800" y="1939680"/>
            <a:ext cx="2638440" cy="2616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99880" y="4804560"/>
            <a:ext cx="2638440" cy="2616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070800" y="4804560"/>
            <a:ext cx="2638440" cy="2616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FAA319-FDC7-427E-97A7-F9B2A6C1A94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99880" y="333000"/>
            <a:ext cx="5407200" cy="138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99880" y="1939680"/>
            <a:ext cx="1740960" cy="2616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128320" y="1939680"/>
            <a:ext cx="1740960" cy="2616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3956760" y="1939680"/>
            <a:ext cx="1740960" cy="2616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99880" y="4804560"/>
            <a:ext cx="1740960" cy="2616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128320" y="4804560"/>
            <a:ext cx="1740960" cy="2616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3956760" y="4804560"/>
            <a:ext cx="1740960" cy="2616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AEE8F3-F47A-4C95-AEC5-4F665DE7998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99880" y="333000"/>
            <a:ext cx="5407200" cy="138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99880" y="1939680"/>
            <a:ext cx="5407200" cy="5484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6BD280-412F-4A1F-B3D5-BA59437C39E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99880" y="333000"/>
            <a:ext cx="5407200" cy="138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99880" y="1939680"/>
            <a:ext cx="5407200" cy="5484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2BE07E-4B0B-46A5-99BB-F6B66BFD5C0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99880" y="333000"/>
            <a:ext cx="5407200" cy="138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99880" y="1939680"/>
            <a:ext cx="2638440" cy="5484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070800" y="1939680"/>
            <a:ext cx="2638440" cy="5484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906675-06E9-46E6-986D-ED34965F938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99880" y="333000"/>
            <a:ext cx="5407200" cy="138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F03FBD-CCA5-4076-8ACF-4CCD9C7AF4D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99880" y="333000"/>
            <a:ext cx="5407200" cy="6417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B96508-F8CC-4C1C-99C5-7463BFA22A5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99880" y="333000"/>
            <a:ext cx="5407200" cy="138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99880" y="1939680"/>
            <a:ext cx="2638440" cy="2616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070800" y="1939680"/>
            <a:ext cx="2638440" cy="5484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99880" y="4804560"/>
            <a:ext cx="2638440" cy="2616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783307-68D6-4A73-BF98-4BC2D54C6C0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99880" y="333000"/>
            <a:ext cx="5407200" cy="138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99880" y="1939680"/>
            <a:ext cx="2638440" cy="5484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070800" y="1939680"/>
            <a:ext cx="2638440" cy="2616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070800" y="4804560"/>
            <a:ext cx="2638440" cy="2616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6A9ACF-6B3F-42EE-885D-E79C4142BA3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99880" y="333000"/>
            <a:ext cx="5407200" cy="138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99880" y="1939680"/>
            <a:ext cx="2638440" cy="2616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070800" y="1939680"/>
            <a:ext cx="2638440" cy="2616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99880" y="4804560"/>
            <a:ext cx="5407200" cy="2616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CA1746-8725-4BA3-814A-9D9784E87DC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99880" y="333000"/>
            <a:ext cx="5407200" cy="138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99880" y="1939680"/>
            <a:ext cx="5407200" cy="5484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99880" y="7703640"/>
            <a:ext cx="1401840" cy="443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052360" y="7703640"/>
            <a:ext cx="1901880" cy="443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305240" y="7703640"/>
            <a:ext cx="1401840" cy="443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1D312F7-2D57-4BAC-8752-1C269C8704C6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10.png"/><Relationship Id="rId3" Type="http://schemas.openxmlformats.org/officeDocument/2006/relationships/image" Target="../media/image11.png"/><Relationship Id="rId4" Type="http://schemas.openxmlformats.org/officeDocument/2006/relationships/image" Target="../media/image12.png"/><Relationship Id="rId5" Type="http://schemas.openxmlformats.org/officeDocument/2006/relationships/image" Target="../media/image13.png"/><Relationship Id="rId6" Type="http://schemas.openxmlformats.org/officeDocument/2006/relationships/image" Target="../media/image14.png"/><Relationship Id="rId7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image" Target="../media/image16.png"/><Relationship Id="rId3" Type="http://schemas.openxmlformats.org/officeDocument/2006/relationships/image" Target="../media/image17.jpeg"/><Relationship Id="rId4" Type="http://schemas.openxmlformats.org/officeDocument/2006/relationships/image" Target="../media/image18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"/>
          <p:cNvSpPr/>
          <p:nvPr/>
        </p:nvSpPr>
        <p:spPr>
          <a:xfrm>
            <a:off x="565200" y="2479680"/>
            <a:ext cx="5029200" cy="311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“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Reduced Malignancy as a Mechanism for Longevity in Mice with Adenylyl Cyclase Type 5 (AC5) Disruption”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 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Mariana S. De Lorenzo et al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PPORTING INFORMAT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2" name="Group 13"/>
          <p:cNvGrpSpPr/>
          <p:nvPr/>
        </p:nvGrpSpPr>
        <p:grpSpPr>
          <a:xfrm>
            <a:off x="842040" y="574560"/>
            <a:ext cx="3761640" cy="2895840"/>
            <a:chOff x="842040" y="574560"/>
            <a:chExt cx="3761640" cy="2895840"/>
          </a:xfrm>
        </p:grpSpPr>
        <p:pic>
          <p:nvPicPr>
            <p:cNvPr id="43" name="Picture 6" descr="12-185.14445.liverCA.jpg"/>
            <p:cNvPicPr/>
            <p:nvPr/>
          </p:nvPicPr>
          <p:blipFill>
            <a:blip r:embed="rId1"/>
            <a:stretch/>
          </p:blipFill>
          <p:spPr>
            <a:xfrm>
              <a:off x="857520" y="961560"/>
              <a:ext cx="1226880" cy="1014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TextBox 8"/>
            <p:cNvSpPr/>
            <p:nvPr/>
          </p:nvSpPr>
          <p:spPr>
            <a:xfrm>
              <a:off x="842040" y="574560"/>
              <a:ext cx="111204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Hepatocellula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Carcinom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5" name="Picture 9" descr="12-185.14451.lymphoma.jpg"/>
            <p:cNvPicPr/>
            <p:nvPr/>
          </p:nvPicPr>
          <p:blipFill>
            <a:blip r:embed="rId2"/>
            <a:stretch/>
          </p:blipFill>
          <p:spPr>
            <a:xfrm>
              <a:off x="3376800" y="961560"/>
              <a:ext cx="1226880" cy="1023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6" name="TextBox 10"/>
            <p:cNvSpPr/>
            <p:nvPr/>
          </p:nvSpPr>
          <p:spPr>
            <a:xfrm>
              <a:off x="3515760" y="674640"/>
              <a:ext cx="884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Lymphom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7" name="Picture 11" descr="12-185.14453.pulmCA.jpg"/>
            <p:cNvPicPr/>
            <p:nvPr/>
          </p:nvPicPr>
          <p:blipFill>
            <a:blip r:embed="rId3"/>
            <a:stretch/>
          </p:blipFill>
          <p:spPr>
            <a:xfrm>
              <a:off x="2117160" y="1720800"/>
              <a:ext cx="1226880" cy="1023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8" name="TextBox 12"/>
            <p:cNvSpPr/>
            <p:nvPr/>
          </p:nvSpPr>
          <p:spPr>
            <a:xfrm>
              <a:off x="2067120" y="1260360"/>
              <a:ext cx="12553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Pulmonary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Adenocarcinom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9" name="Picture 15" descr="12-185.14445.histiocyticSA.jpg"/>
            <p:cNvPicPr/>
            <p:nvPr/>
          </p:nvPicPr>
          <p:blipFill>
            <a:blip r:embed="rId4"/>
            <a:stretch/>
          </p:blipFill>
          <p:spPr>
            <a:xfrm>
              <a:off x="857520" y="2447280"/>
              <a:ext cx="1226880" cy="1023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0" name="Picture 16" descr="12-185.14445.schwannoma.jpg"/>
            <p:cNvPicPr/>
            <p:nvPr/>
          </p:nvPicPr>
          <p:blipFill>
            <a:blip r:embed="rId5"/>
            <a:stretch/>
          </p:blipFill>
          <p:spPr>
            <a:xfrm>
              <a:off x="3376800" y="2447280"/>
              <a:ext cx="1226880" cy="1023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1" name="TextBox 17"/>
            <p:cNvSpPr/>
            <p:nvPr/>
          </p:nvSpPr>
          <p:spPr>
            <a:xfrm>
              <a:off x="3406680" y="2201040"/>
              <a:ext cx="1067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 </a:t>
              </a: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Schwannom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Box 11"/>
            <p:cNvSpPr/>
            <p:nvPr/>
          </p:nvSpPr>
          <p:spPr>
            <a:xfrm>
              <a:off x="937440" y="2059920"/>
              <a:ext cx="8377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Histiocyti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Sarcom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3" name="TextBox 24"/>
          <p:cNvSpPr/>
          <p:nvPr/>
        </p:nvSpPr>
        <p:spPr>
          <a:xfrm>
            <a:off x="260280" y="6823080"/>
            <a:ext cx="5410440" cy="10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Figure S1: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Genetically modified AC5x MMTV-Her-2-Neu mice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. Mice showed a significant delay in tumor incidence by log-rank test and by chi-square test *p&lt;0.05. These mice were in a mixed 129SVJ/C57BL/6 and FVB background. Different tumor types were found in AC5xMMTV-Her-2-Neu mice. Representative photographs show the most frequent tumor pathologies found in AC5KO Neu</a:t>
            </a:r>
            <a:r>
              <a:rPr b="0" lang="en-US" sz="11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+/-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and AC5HET Neu</a:t>
            </a:r>
            <a:r>
              <a:rPr b="0" lang="en-US" sz="11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+/-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mice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4" name="Group 17"/>
          <p:cNvGrpSpPr/>
          <p:nvPr/>
        </p:nvGrpSpPr>
        <p:grpSpPr>
          <a:xfrm>
            <a:off x="871200" y="3546360"/>
            <a:ext cx="2589480" cy="3048120"/>
            <a:chOff x="871200" y="3546360"/>
            <a:chExt cx="2589480" cy="3048120"/>
          </a:xfrm>
        </p:grpSpPr>
        <p:pic>
          <p:nvPicPr>
            <p:cNvPr id="55" name="Picture 10" descr="12-185.14a.mammary KO.HE.jpg"/>
            <p:cNvPicPr/>
            <p:nvPr/>
          </p:nvPicPr>
          <p:blipFill>
            <a:blip r:embed="rId6"/>
            <a:stretch/>
          </p:blipFill>
          <p:spPr>
            <a:xfrm>
              <a:off x="2044800" y="5607720"/>
              <a:ext cx="1415880" cy="986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6" name="Picture 11" descr="12-185.15a.mammary HET.HE.jpg"/>
            <p:cNvPicPr/>
            <p:nvPr/>
          </p:nvPicPr>
          <p:blipFill>
            <a:blip r:embed="rId7"/>
            <a:stretch/>
          </p:blipFill>
          <p:spPr>
            <a:xfrm>
              <a:off x="2039760" y="4589280"/>
              <a:ext cx="1398960" cy="986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7" name="Picture 12" descr="12-185.42a.mammary HET.HE.jpg"/>
            <p:cNvPicPr/>
            <p:nvPr/>
          </p:nvPicPr>
          <p:blipFill>
            <a:blip r:embed="rId8"/>
            <a:stretch/>
          </p:blipFill>
          <p:spPr>
            <a:xfrm>
              <a:off x="2039760" y="3546360"/>
              <a:ext cx="1405800" cy="994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8" name="TextBox 16"/>
            <p:cNvSpPr/>
            <p:nvPr/>
          </p:nvSpPr>
          <p:spPr>
            <a:xfrm>
              <a:off x="1125000" y="3978720"/>
              <a:ext cx="743040" cy="550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Mammary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Squamou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Carcinom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Box 16"/>
            <p:cNvSpPr/>
            <p:nvPr/>
          </p:nvSpPr>
          <p:spPr>
            <a:xfrm>
              <a:off x="1125000" y="5069880"/>
              <a:ext cx="743040" cy="550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Mammary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Carcinom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Acina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Box 11"/>
            <p:cNvSpPr/>
            <p:nvPr/>
          </p:nvSpPr>
          <p:spPr>
            <a:xfrm>
              <a:off x="973080" y="5806800"/>
              <a:ext cx="878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AC5KO Neu</a:t>
              </a:r>
              <a:r>
                <a:rPr b="1" lang="en-US" sz="1000" spc="-1" strike="noStrike" baseline="30000">
                  <a:solidFill>
                    <a:srgbClr val="000000"/>
                  </a:solidFill>
                  <a:latin typeface="Calibri"/>
                </a:rPr>
                <a:t>+/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Box 12"/>
            <p:cNvSpPr/>
            <p:nvPr/>
          </p:nvSpPr>
          <p:spPr>
            <a:xfrm>
              <a:off x="871200" y="3817080"/>
              <a:ext cx="956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AC5 HET Neu</a:t>
              </a:r>
              <a:r>
                <a:rPr b="1" lang="en-US" sz="1000" spc="-1" strike="noStrike" baseline="30000">
                  <a:solidFill>
                    <a:srgbClr val="000000"/>
                  </a:solidFill>
                  <a:latin typeface="Calibri"/>
                </a:rPr>
                <a:t>+/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TextBox 12"/>
            <p:cNvSpPr/>
            <p:nvPr/>
          </p:nvSpPr>
          <p:spPr>
            <a:xfrm>
              <a:off x="871200" y="4892040"/>
              <a:ext cx="956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AC5 HET Neu</a:t>
              </a:r>
              <a:r>
                <a:rPr b="1" lang="en-US" sz="1000" spc="-1" strike="noStrike" baseline="30000">
                  <a:solidFill>
                    <a:srgbClr val="000000"/>
                  </a:solidFill>
                  <a:latin typeface="Calibri"/>
                </a:rPr>
                <a:t>+/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TextBox 16"/>
            <p:cNvSpPr/>
            <p:nvPr/>
          </p:nvSpPr>
          <p:spPr>
            <a:xfrm>
              <a:off x="1125000" y="5955120"/>
              <a:ext cx="743040" cy="550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Mammary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Carcinom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Acina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4" name="TextBox 35"/>
          <p:cNvSpPr/>
          <p:nvPr/>
        </p:nvSpPr>
        <p:spPr>
          <a:xfrm>
            <a:off x="-501480" y="0"/>
            <a:ext cx="69102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AC5KO x MMTV-Her-2 Neu MICE SHOW A DELA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IN AGE-RELATED  and MAMMARY TUMOR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TextBox 85"/>
          <p:cNvSpPr/>
          <p:nvPr/>
        </p:nvSpPr>
        <p:spPr>
          <a:xfrm>
            <a:off x="368280" y="0"/>
            <a:ext cx="563868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AC5 INHIBITOR REDUCES CELL PROLIFERATION, ADHESION AND MIGRATIO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25"/>
          <p:cNvSpPr/>
          <p:nvPr/>
        </p:nvSpPr>
        <p:spPr>
          <a:xfrm>
            <a:off x="304920" y="271440"/>
            <a:ext cx="677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(A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26"/>
          <p:cNvSpPr/>
          <p:nvPr/>
        </p:nvSpPr>
        <p:spPr>
          <a:xfrm>
            <a:off x="304920" y="2158920"/>
            <a:ext cx="641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(B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26"/>
          <p:cNvSpPr/>
          <p:nvPr/>
        </p:nvSpPr>
        <p:spPr>
          <a:xfrm>
            <a:off x="304920" y="3530520"/>
            <a:ext cx="685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(C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26"/>
          <p:cNvSpPr/>
          <p:nvPr/>
        </p:nvSpPr>
        <p:spPr>
          <a:xfrm>
            <a:off x="3173400" y="271440"/>
            <a:ext cx="515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(D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Box 26"/>
          <p:cNvSpPr/>
          <p:nvPr/>
        </p:nvSpPr>
        <p:spPr>
          <a:xfrm>
            <a:off x="3173400" y="2158920"/>
            <a:ext cx="685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(E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Box 26"/>
          <p:cNvSpPr/>
          <p:nvPr/>
        </p:nvSpPr>
        <p:spPr>
          <a:xfrm>
            <a:off x="3173400" y="3530520"/>
            <a:ext cx="520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(F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2" name="Picture 10" descr=""/>
          <p:cNvPicPr/>
          <p:nvPr/>
        </p:nvPicPr>
        <p:blipFill>
          <a:blip r:embed="rId1"/>
          <a:stretch/>
        </p:blipFill>
        <p:spPr>
          <a:xfrm>
            <a:off x="3689280" y="3683160"/>
            <a:ext cx="1623960" cy="1539720"/>
          </a:xfrm>
          <a:prstGeom prst="rect">
            <a:avLst/>
          </a:prstGeom>
          <a:ln w="0">
            <a:noFill/>
          </a:ln>
        </p:spPr>
      </p:pic>
      <p:sp>
        <p:nvSpPr>
          <p:cNvPr id="73" name="TextBox 59"/>
          <p:cNvSpPr/>
          <p:nvPr/>
        </p:nvSpPr>
        <p:spPr>
          <a:xfrm>
            <a:off x="4375080" y="3759120"/>
            <a:ext cx="1017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LLC1-Migrati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Box 34"/>
          <p:cNvSpPr/>
          <p:nvPr/>
        </p:nvSpPr>
        <p:spPr>
          <a:xfrm>
            <a:off x="0" y="5300640"/>
            <a:ext cx="6006960" cy="2962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Figure S2: AC5 inhibitor reduces cell proliferation, adhesion and migration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. (A) 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LP07 unsynchronized growing cultures in basal medium were grown until 72h in the presence of vehicle or AC5 inhibitor (0-50µM). The viability of LP07 cells was inhibited by AC5 inhibitor in a dose-dependent manner and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the IC</a:t>
            </a:r>
            <a:r>
              <a:rPr b="0" lang="en-US" sz="11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50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was 1µM.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(B)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B16F10 melanoma cells 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attached to the plate were grown for 48h in basal medium in the presence of vehicle or AC5 inhibitor (0-20µM). The viability of B16F10 was inhibited by the AC5 inhibitor in a dose-dependent manner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.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(C)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 LLC1 lung cancer cells attached to the plate were grown for 48h in basal medium in the presence of vehicle or AC5 inhibitor (0-20µM). The viability of LLC1 was inhibited by the AC5 inhibitor in a dose-dependent manner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.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(D)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Human umbilical vein cells (HUVEC) attached to the plate were grown for 24h in endothelial growth medium (EGM-2) in the presence of vehicle or AC5 inhibitor (0-50µM). The viability of HUVEC was inhibited by the AC5 inhibitor in a dose-dependent manner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.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(E)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The adhesive capacity of LLC1 cells after 90 min; and AC5 inhibitor significantly reduces the </a:t>
            </a:r>
            <a:r>
              <a:rPr b="0" i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in vitro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 adhesive capacities of tumor cells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.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(F)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The migratory capacity of LLC1 cells was evaluated using the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in vitro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wound assay. Cells were pre-treated overnight and co-treated for 7 h in medium with 2% FBS in the presence of vehicle or AC5 inhibitor (0-5µM). 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A significant difference was observed in the number of cancer cells that migrated.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**p&lt;0.01 and *p&lt;0.05 vs. vehicle;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n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=3-12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5" name="Picture 17" descr=""/>
          <p:cNvPicPr/>
          <p:nvPr/>
        </p:nvPicPr>
        <p:blipFill>
          <a:blip r:embed="rId2"/>
          <a:stretch/>
        </p:blipFill>
        <p:spPr>
          <a:xfrm>
            <a:off x="641520" y="574560"/>
            <a:ext cx="2057400" cy="1638360"/>
          </a:xfrm>
          <a:prstGeom prst="rect">
            <a:avLst/>
          </a:prstGeom>
          <a:ln w="0">
            <a:noFill/>
          </a:ln>
        </p:spPr>
      </p:pic>
      <p:pic>
        <p:nvPicPr>
          <p:cNvPr id="76" name="Picture 18" descr=""/>
          <p:cNvPicPr/>
          <p:nvPr/>
        </p:nvPicPr>
        <p:blipFill>
          <a:blip r:embed="rId3"/>
          <a:stretch/>
        </p:blipFill>
        <p:spPr>
          <a:xfrm>
            <a:off x="3232080" y="650880"/>
            <a:ext cx="2457360" cy="1438200"/>
          </a:xfrm>
          <a:prstGeom prst="rect">
            <a:avLst/>
          </a:prstGeom>
          <a:ln w="0">
            <a:noFill/>
          </a:ln>
        </p:spPr>
      </p:pic>
      <p:pic>
        <p:nvPicPr>
          <p:cNvPr id="77" name="Picture 19" descr=""/>
          <p:cNvPicPr/>
          <p:nvPr/>
        </p:nvPicPr>
        <p:blipFill>
          <a:blip r:embed="rId4"/>
          <a:stretch/>
        </p:blipFill>
        <p:spPr>
          <a:xfrm>
            <a:off x="793800" y="2327400"/>
            <a:ext cx="1914480" cy="1352520"/>
          </a:xfrm>
          <a:prstGeom prst="rect">
            <a:avLst/>
          </a:prstGeom>
          <a:ln w="0">
            <a:noFill/>
          </a:ln>
        </p:spPr>
      </p:pic>
      <p:pic>
        <p:nvPicPr>
          <p:cNvPr id="78" name="Picture 20" descr=""/>
          <p:cNvPicPr/>
          <p:nvPr/>
        </p:nvPicPr>
        <p:blipFill>
          <a:blip r:embed="rId5"/>
          <a:stretch/>
        </p:blipFill>
        <p:spPr>
          <a:xfrm>
            <a:off x="3613320" y="2174760"/>
            <a:ext cx="1523880" cy="1428840"/>
          </a:xfrm>
          <a:prstGeom prst="rect">
            <a:avLst/>
          </a:prstGeom>
          <a:ln w="0">
            <a:noFill/>
          </a:ln>
        </p:spPr>
      </p:pic>
      <p:pic>
        <p:nvPicPr>
          <p:cNvPr id="79" name="Picture 21" descr=""/>
          <p:cNvPicPr/>
          <p:nvPr/>
        </p:nvPicPr>
        <p:blipFill>
          <a:blip r:embed="rId6"/>
          <a:stretch/>
        </p:blipFill>
        <p:spPr>
          <a:xfrm>
            <a:off x="851040" y="3774960"/>
            <a:ext cx="2000160" cy="1295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0" name="Picture 42" descr=""/>
          <p:cNvPicPr/>
          <p:nvPr/>
        </p:nvPicPr>
        <p:blipFill>
          <a:blip r:embed="rId1"/>
          <a:stretch/>
        </p:blipFill>
        <p:spPr>
          <a:xfrm>
            <a:off x="1393920" y="625320"/>
            <a:ext cx="2600280" cy="1508400"/>
          </a:xfrm>
          <a:prstGeom prst="rect">
            <a:avLst/>
          </a:prstGeom>
          <a:ln w="0">
            <a:noFill/>
          </a:ln>
        </p:spPr>
      </p:pic>
      <p:sp>
        <p:nvSpPr>
          <p:cNvPr id="81" name="TextBox 3"/>
          <p:cNvSpPr/>
          <p:nvPr/>
        </p:nvSpPr>
        <p:spPr>
          <a:xfrm>
            <a:off x="340920" y="193680"/>
            <a:ext cx="461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(A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Box 4"/>
          <p:cNvSpPr/>
          <p:nvPr/>
        </p:nvSpPr>
        <p:spPr>
          <a:xfrm>
            <a:off x="336600" y="2174760"/>
            <a:ext cx="627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(B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3" name="Picture 19" descr=""/>
          <p:cNvPicPr/>
          <p:nvPr/>
        </p:nvPicPr>
        <p:blipFill>
          <a:blip r:embed="rId2"/>
          <a:stretch/>
        </p:blipFill>
        <p:spPr>
          <a:xfrm>
            <a:off x="2841480" y="2936880"/>
            <a:ext cx="1052640" cy="450720"/>
          </a:xfrm>
          <a:prstGeom prst="rect">
            <a:avLst/>
          </a:prstGeom>
          <a:ln w="0">
            <a:noFill/>
          </a:ln>
        </p:spPr>
      </p:pic>
      <p:grpSp>
        <p:nvGrpSpPr>
          <p:cNvPr id="84" name="Group 160"/>
          <p:cNvGrpSpPr/>
          <p:nvPr/>
        </p:nvGrpSpPr>
        <p:grpSpPr>
          <a:xfrm>
            <a:off x="638280" y="4384800"/>
            <a:ext cx="3657600" cy="1703880"/>
            <a:chOff x="638280" y="4384800"/>
            <a:chExt cx="3657600" cy="1703880"/>
          </a:xfrm>
        </p:grpSpPr>
        <p:sp>
          <p:nvSpPr>
            <p:cNvPr id="85" name="TextBox 15"/>
            <p:cNvSpPr/>
            <p:nvPr/>
          </p:nvSpPr>
          <p:spPr>
            <a:xfrm>
              <a:off x="2689200" y="5812200"/>
              <a:ext cx="1443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AC5 inhibitor (5µM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TextBox 16"/>
            <p:cNvSpPr/>
            <p:nvPr/>
          </p:nvSpPr>
          <p:spPr>
            <a:xfrm>
              <a:off x="2264400" y="4384800"/>
              <a:ext cx="20293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Calibri"/>
                </a:rPr>
                <a:t> </a:t>
              </a:r>
              <a:r>
                <a:rPr b="1" lang="en-US" sz="1100" spc="-1" strike="noStrike">
                  <a:solidFill>
                    <a:srgbClr val="000000"/>
                  </a:solidFill>
                  <a:latin typeface="Calibri"/>
                </a:rPr>
                <a:t>0            24            48           72  hs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TextBox 24"/>
            <p:cNvSpPr/>
            <p:nvPr/>
          </p:nvSpPr>
          <p:spPr>
            <a:xfrm>
              <a:off x="638280" y="4800960"/>
              <a:ext cx="14605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</a:rPr>
                <a:t>Cleaved Caspase -3 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TextBox 25"/>
            <p:cNvSpPr/>
            <p:nvPr/>
          </p:nvSpPr>
          <p:spPr>
            <a:xfrm>
              <a:off x="1643400" y="5074920"/>
              <a:ext cx="4626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</a:rPr>
                <a:t>Bcl-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TextBox 26"/>
            <p:cNvSpPr/>
            <p:nvPr/>
          </p:nvSpPr>
          <p:spPr>
            <a:xfrm>
              <a:off x="1336680" y="5336280"/>
              <a:ext cx="8247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l-GR" sz="1100" spc="-1" strike="noStrike">
                  <a:solidFill>
                    <a:srgbClr val="000000"/>
                  </a:solidFill>
                  <a:latin typeface="Calibri"/>
                </a:rPr>
                <a:t>β</a:t>
              </a:r>
              <a:r>
                <a:rPr b="0" lang="en-US" sz="1100" spc="-1" strike="noStrike">
                  <a:solidFill>
                    <a:srgbClr val="000000"/>
                  </a:solidFill>
                  <a:latin typeface="Calibri"/>
                </a:rPr>
                <a:t>-actin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90" name="Picture 26" descr=""/>
            <p:cNvPicPr/>
            <p:nvPr/>
          </p:nvPicPr>
          <p:blipFill>
            <a:blip r:embed="rId3"/>
            <a:stretch/>
          </p:blipFill>
          <p:spPr>
            <a:xfrm>
              <a:off x="2080800" y="4741560"/>
              <a:ext cx="2215080" cy="1040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1" name="Straight Connector 15"/>
            <p:cNvSpPr/>
            <p:nvPr/>
          </p:nvSpPr>
          <p:spPr>
            <a:xfrm>
              <a:off x="2200320" y="4681440"/>
              <a:ext cx="4158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Straight Connector 16"/>
            <p:cNvSpPr/>
            <p:nvPr/>
          </p:nvSpPr>
          <p:spPr>
            <a:xfrm>
              <a:off x="2735280" y="4681440"/>
              <a:ext cx="4158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Straight Connector 17"/>
            <p:cNvSpPr/>
            <p:nvPr/>
          </p:nvSpPr>
          <p:spPr>
            <a:xfrm>
              <a:off x="3270600" y="4681440"/>
              <a:ext cx="355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Straight Connector 18"/>
            <p:cNvSpPr/>
            <p:nvPr/>
          </p:nvSpPr>
          <p:spPr>
            <a:xfrm>
              <a:off x="3745080" y="4681440"/>
              <a:ext cx="4158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5" name="TextBox 3"/>
          <p:cNvSpPr/>
          <p:nvPr/>
        </p:nvSpPr>
        <p:spPr>
          <a:xfrm>
            <a:off x="368640" y="4384800"/>
            <a:ext cx="497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(C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Box 19"/>
          <p:cNvSpPr/>
          <p:nvPr/>
        </p:nvSpPr>
        <p:spPr>
          <a:xfrm>
            <a:off x="152280" y="6289560"/>
            <a:ext cx="5747040" cy="193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Figure S3: AC5 inhibitor increases apoptosis in LP07 cells.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(A)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 R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epresentative DNA histogram of LPO7 cells after treatment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 for 48h in the presence of vehicle or different doses of the AC5 inhibitor (0-5µM). AC5 inhibitor caused a decrease in the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G0-G1 phase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, an accumulation of apoptotic cells and a corresponding decrease in S phase.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(B)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 LP07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lung tumor cells were treated for 48h with vehicle or AC5 inhibitor (5µM) in the absence of serum. Cells were stained using Annexin-V FITC and data were obtained by flow cytometry analysis. Values are expressed as % of cells on early and late apoptosis in each condition. **p&lt;0.01 vs. vehicle;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n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=4.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(C)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Western blot analysis was performed for Cleaved Capsase-3 and Bcl-2 in order to confirm the induction of apoptosis. Each lane represents one individual well from each treatment and time point and </a:t>
            </a:r>
            <a:r>
              <a:rPr b="0" lang="en-US" sz="11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-actin was used as a loading control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7" name="Picture 20" descr=""/>
          <p:cNvPicPr/>
          <p:nvPr/>
        </p:nvPicPr>
        <p:blipFill>
          <a:blip r:embed="rId4"/>
          <a:stretch/>
        </p:blipFill>
        <p:spPr>
          <a:xfrm>
            <a:off x="1098720" y="2479680"/>
            <a:ext cx="1638000" cy="15620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5-17T17:18:22Z</dcterms:created>
  <dc:creator>rahmanmm</dc:creator>
  <dc:description/>
  <dc:language>en-US</dc:language>
  <cp:lastModifiedBy>rahmanmm</cp:lastModifiedBy>
  <dcterms:modified xsi:type="dcterms:W3CDTF">2013-08-05T18:29:48Z</dcterms:modified>
  <cp:revision>40</cp:revision>
  <dc:subject/>
  <dc:title>Slide 1</dc:title>
</cp:coreProperties>
</file>